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687E24-2E27-4A5B-9D21-9703EAEA087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413DBC-4BF7-4770-8416-1C39B62AD83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EF747E-3A2E-48FE-8CCD-5D7A3FF26D0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A06FC5-6507-4E36-AA70-46F7725EC7D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6FFEC5-8E09-427A-B195-A4D60E68F9A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DF00F5-79CA-440B-9BA3-A29BE0B5F6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38F9D7-AC5F-4409-B633-B878B18502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60B0DC-81BA-4394-AAAF-057EEC0C870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A90D5A-6768-4B62-804A-E3792713C73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DEDDE2-0F98-4A2D-B128-B28328C803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3A8AB9-2DC7-4C6F-9BF7-02081F671C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9D928F-D473-4AA9-8797-7466513EA3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1AE1724-4FFD-4064-925A-7CDA4D3F4CA0}" type="datetime">
              <a:rPr b="0" lang="it-IT" sz="1200" spc="-1" strike="noStrike">
                <a:solidFill>
                  <a:srgbClr val="898989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0805E26-32B5-41E8-B6F9-0F3DC117197C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Grafico 3" descr=""/>
          <p:cNvPicPr/>
          <p:nvPr/>
        </p:nvPicPr>
        <p:blipFill>
          <a:blip r:embed="rId1"/>
          <a:stretch/>
        </p:blipFill>
        <p:spPr>
          <a:xfrm>
            <a:off x="523800" y="426960"/>
            <a:ext cx="6413400" cy="5443560"/>
          </a:xfrm>
          <a:prstGeom prst="rect">
            <a:avLst/>
          </a:prstGeom>
          <a:ln w="0">
            <a:noFill/>
          </a:ln>
        </p:spPr>
      </p:pic>
      <p:sp>
        <p:nvSpPr>
          <p:cNvPr id="42" name="CasellaDiTesto 4"/>
          <p:cNvSpPr/>
          <p:nvPr/>
        </p:nvSpPr>
        <p:spPr>
          <a:xfrm>
            <a:off x="407880" y="5799240"/>
            <a:ext cx="812664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Supplementary Figure 1.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Functional categorization of Tentative Consensus (TCs) showing differential hybridization signals in IL10-1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vs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. M82. Categorization was performed according to GO Biological Process (BP) vocabulary as retrieved through Blast2GO Gene Ontology mapping. Differentially expressed TCs were categorized as split into up-regulated and down-regulated TCs and  calculated as percentage of the total number of classifications 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Gruppo 10"/>
          <p:cNvGrpSpPr/>
          <p:nvPr/>
        </p:nvGrpSpPr>
        <p:grpSpPr>
          <a:xfrm>
            <a:off x="6804000" y="1197000"/>
            <a:ext cx="1528560" cy="480960"/>
            <a:chOff x="6804000" y="1197000"/>
            <a:chExt cx="1528560" cy="480960"/>
          </a:xfrm>
        </p:grpSpPr>
        <p:sp>
          <p:nvSpPr>
            <p:cNvPr id="44" name="Rettangolo 6"/>
            <p:cNvSpPr/>
            <p:nvPr/>
          </p:nvSpPr>
          <p:spPr>
            <a:xfrm>
              <a:off x="6804000" y="1268280"/>
              <a:ext cx="107640" cy="108000"/>
            </a:xfrm>
            <a:prstGeom prst="rect">
              <a:avLst/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Rettangolo 7"/>
            <p:cNvSpPr/>
            <p:nvPr/>
          </p:nvSpPr>
          <p:spPr>
            <a:xfrm>
              <a:off x="6804000" y="1492200"/>
              <a:ext cx="107640" cy="108000"/>
            </a:xfrm>
            <a:prstGeom prst="rect">
              <a:avLst/>
            </a:prstGeom>
            <a:solidFill>
              <a:srgbClr val="7f7f7f"/>
            </a:solidFill>
            <a:ln w="255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CasellaDiTesto 8"/>
            <p:cNvSpPr/>
            <p:nvPr/>
          </p:nvSpPr>
          <p:spPr>
            <a:xfrm>
              <a:off x="6914880" y="1197000"/>
              <a:ext cx="12384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Upregulated TC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CasellaDiTesto 9"/>
            <p:cNvSpPr/>
            <p:nvPr/>
          </p:nvSpPr>
          <p:spPr>
            <a:xfrm>
              <a:off x="6915960" y="1416600"/>
              <a:ext cx="1416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it-IT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Downregulated TC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09T10:48:52Z</dcterms:created>
  <dc:creator>amalia  barone</dc:creator>
  <dc:description/>
  <dc:language>en-US</dc:language>
  <cp:lastModifiedBy>Amalia</cp:lastModifiedBy>
  <dcterms:modified xsi:type="dcterms:W3CDTF">2011-12-29T14:45:21Z</dcterms:modified>
  <cp:revision>6</cp:revision>
  <dc:subject/>
  <dc:title>Diapositiva 1</dc:title>
</cp:coreProperties>
</file>